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6" r:id="rId2"/>
    <p:sldId id="267" r:id="rId3"/>
    <p:sldId id="268" r:id="rId4"/>
    <p:sldId id="269" r:id="rId5"/>
    <p:sldId id="272" r:id="rId6"/>
    <p:sldId id="270" r:id="rId7"/>
    <p:sldId id="264" r:id="rId8"/>
    <p:sldId id="275" r:id="rId9"/>
    <p:sldId id="276" r:id="rId10"/>
  </p:sldIdLst>
  <p:sldSz cx="7773988" cy="100599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69">
          <p15:clr>
            <a:srgbClr val="A4A3A4"/>
          </p15:clr>
        </p15:guide>
        <p15:guide id="2" pos="244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E91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54"/>
    <p:restoredTop sz="94495"/>
  </p:normalViewPr>
  <p:slideViewPr>
    <p:cSldViewPr>
      <p:cViewPr>
        <p:scale>
          <a:sx n="70" d="100"/>
          <a:sy n="70" d="100"/>
        </p:scale>
        <p:origin x="-3552" y="-186"/>
      </p:cViewPr>
      <p:guideLst>
        <p:guide orient="horz" pos="3169"/>
        <p:guide pos="24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C720C3-77CF-404C-98A6-B29F73D77C0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0EF9DB-BE0F-400D-9B25-3D28B60BEA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77406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3049" y="3125119"/>
            <a:ext cx="6607890" cy="215637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6098" y="5700660"/>
            <a:ext cx="5441792" cy="257088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0540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5933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2611" y="402868"/>
            <a:ext cx="1485965" cy="85835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666" y="402868"/>
            <a:ext cx="4332379" cy="85835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8082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5999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91" y="6464476"/>
            <a:ext cx="6607890" cy="199802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91" y="4263853"/>
            <a:ext cx="6607890" cy="220062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2594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701" y="2347333"/>
            <a:ext cx="3433511" cy="663912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1778" y="2347333"/>
            <a:ext cx="3433511" cy="663912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8562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701" y="2251854"/>
            <a:ext cx="3434861" cy="9384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701" y="3190320"/>
            <a:ext cx="3434861" cy="57961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9079" y="2251854"/>
            <a:ext cx="3436211" cy="9384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9079" y="3190320"/>
            <a:ext cx="3436211" cy="57961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206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4034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7407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700" y="400537"/>
            <a:ext cx="2557588" cy="170460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9414" y="400539"/>
            <a:ext cx="4345875" cy="85859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700" y="2105148"/>
            <a:ext cx="2557588" cy="68813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9038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757" y="7041992"/>
            <a:ext cx="4664393" cy="83134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757" y="898878"/>
            <a:ext cx="4664393" cy="603599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757" y="7873338"/>
            <a:ext cx="4664393" cy="11806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8799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701" y="402866"/>
            <a:ext cx="6996589" cy="16766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701" y="2347333"/>
            <a:ext cx="6996589" cy="66391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700" y="9324121"/>
            <a:ext cx="1813931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D23F1-51D6-427F-BAD6-92C59BD9AA4C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6114" y="9324121"/>
            <a:ext cx="2461763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1359" y="9324121"/>
            <a:ext cx="1813931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F9FCB-EA3B-4364-81EB-3D1E243CEC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31246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tiff"/><Relationship Id="rId4" Type="http://schemas.microsoft.com/office/2007/relationships/hdphoto" Target="../media/hdphoto1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7.png"/><Relationship Id="rId7" Type="http://schemas.openxmlformats.org/officeDocument/2006/relationships/image" Target="../media/image2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13" Type="http://schemas.openxmlformats.org/officeDocument/2006/relationships/image" Target="../media/image35.png"/><Relationship Id="rId3" Type="http://schemas.openxmlformats.org/officeDocument/2006/relationships/image" Target="../media/image26.png"/><Relationship Id="rId7" Type="http://schemas.openxmlformats.org/officeDocument/2006/relationships/image" Target="../media/image30.jpeg"/><Relationship Id="rId12" Type="http://schemas.microsoft.com/office/2007/relationships/hdphoto" Target="../media/hdphoto13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jpeg"/><Relationship Id="rId5" Type="http://schemas.openxmlformats.org/officeDocument/2006/relationships/image" Target="../media/image28.png"/><Relationship Id="rId10" Type="http://schemas.openxmlformats.org/officeDocument/2006/relationships/image" Target="../media/image33.jpeg"/><Relationship Id="rId4" Type="http://schemas.openxmlformats.org/officeDocument/2006/relationships/image" Target="../media/image27.png"/><Relationship Id="rId9" Type="http://schemas.openxmlformats.org/officeDocument/2006/relationships/image" Target="../media/image32.jpeg"/><Relationship Id="rId14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tiff"/><Relationship Id="rId4" Type="http://schemas.openxmlformats.org/officeDocument/2006/relationships/image" Target="../media/image41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microsoft.com/office/2007/relationships/hdphoto" Target="../media/hdphoto14.wdp"/><Relationship Id="rId7" Type="http://schemas.openxmlformats.org/officeDocument/2006/relationships/image" Target="../media/image46.pn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microsoft.com/office/2007/relationships/hdphoto" Target="../media/hdphoto15.wdp"/><Relationship Id="rId10" Type="http://schemas.openxmlformats.org/officeDocument/2006/relationships/image" Target="../media/image49.png"/><Relationship Id="rId4" Type="http://schemas.openxmlformats.org/officeDocument/2006/relationships/image" Target="../media/image44.jpeg"/><Relationship Id="rId9" Type="http://schemas.openxmlformats.org/officeDocument/2006/relationships/image" Target="../media/image48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6.wdp"/><Relationship Id="rId7" Type="http://schemas.openxmlformats.org/officeDocument/2006/relationships/image" Target="../media/image54.pn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microsoft.com/office/2007/relationships/hdphoto" Target="../media/hdphoto17.wdp"/><Relationship Id="rId4" Type="http://schemas.openxmlformats.org/officeDocument/2006/relationships/image" Target="../media/image5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TextBox 189">
            <a:extLst>
              <a:ext uri="{FF2B5EF4-FFF2-40B4-BE49-F238E27FC236}">
                <a16:creationId xmlns:a16="http://schemas.microsoft.com/office/drawing/2014/main" xmlns="" id="{70458D55-83D9-394F-A79E-8699C6B28F1C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FEBDA7E2-0358-3F4A-9C1C-14EA26766C76}"/>
              </a:ext>
            </a:extLst>
          </p:cNvPr>
          <p:cNvSpPr/>
          <p:nvPr/>
        </p:nvSpPr>
        <p:spPr>
          <a:xfrm>
            <a:off x="646634" y="7520657"/>
            <a:ext cx="66247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1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mmunostaining for p32 in thre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ifferent human melanoma cells (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K-MEL-2, SK-MEL-28 and A375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howing the expression levels of p32 (red, p32; blue, nuclei)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IN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1366714" y="2455841"/>
            <a:ext cx="4893078" cy="4392006"/>
            <a:chOff x="1366714" y="2005658"/>
            <a:chExt cx="4893078" cy="4392006"/>
          </a:xfrm>
        </p:grpSpPr>
        <p:grpSp>
          <p:nvGrpSpPr>
            <p:cNvPr id="2" name="Group 1"/>
            <p:cNvGrpSpPr/>
            <p:nvPr/>
          </p:nvGrpSpPr>
          <p:grpSpPr>
            <a:xfrm>
              <a:off x="1366714" y="2005658"/>
              <a:ext cx="4847652" cy="4392006"/>
              <a:chOff x="62639" y="2750221"/>
              <a:chExt cx="4847652" cy="4392006"/>
            </a:xfrm>
          </p:grpSpPr>
          <p:pic>
            <p:nvPicPr>
              <p:cNvPr id="3" name="Picture 2" descr="F:\SK28\SK28_Series003Snapshot1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11193" y="4229513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" name="Picture 3" descr="F:\SK28\SK28_Series003_ch00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99025" y="4229673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" name="Picture 4" descr="F:\SK28\SK28_Series003_ch02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448" y="4229673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" name="Picture 5" descr="F:\SK2\SK2_Series001Snapshot1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11193" y="2757119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" name="Picture 6" descr="F:\SK2\SK2_Series001_ch00.t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99025" y="2757119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" name="Picture 7" descr="F:\SK2\SK2_Series001_ch02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448" y="2757119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8" descr="F:\A3\A3_Series001Snapshot1.tif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11193" y="5702227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Picture 9" descr="F:\A3\A3_Series001_ch00.tif"/>
              <p:cNvPicPr>
                <a:picLocks noChangeAspect="1" noChangeArrowheads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99025" y="5702227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10" descr="F:\A3\A3_Series001_ch02.tif"/>
              <p:cNvPicPr>
                <a:picLocks noChangeAspect="1" noChangeArrowheads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448" y="5702227"/>
                <a:ext cx="1499098" cy="144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" name="TextBox 11"/>
              <p:cNvSpPr txBox="1"/>
              <p:nvPr/>
            </p:nvSpPr>
            <p:spPr>
              <a:xfrm rot="16200000">
                <a:off x="-149627" y="3412672"/>
                <a:ext cx="669068" cy="2445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b="1" dirty="0"/>
                  <a:t>SK-MEL-2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-182930" y="4819528"/>
                <a:ext cx="735675" cy="2445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b="1" dirty="0"/>
                  <a:t>SK-MEL-28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-31365" y="6267239"/>
                <a:ext cx="432542" cy="2445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b="1" dirty="0"/>
                  <a:t>A375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86858" y="2750221"/>
                <a:ext cx="762822" cy="2348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solidFill>
                      <a:schemeClr val="bg1"/>
                    </a:solidFill>
                  </a:rPr>
                  <a:t>DAPI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899026" y="2757469"/>
                <a:ext cx="762822" cy="2348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solidFill>
                      <a:schemeClr val="bg1"/>
                    </a:solidFill>
                  </a:rPr>
                  <a:t>p3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427389" y="2757469"/>
                <a:ext cx="762822" cy="2348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solidFill>
                      <a:schemeClr val="bg1"/>
                    </a:solidFill>
                  </a:rPr>
                  <a:t>Merged</a:t>
                </a:r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5834676" y="6089139"/>
              <a:ext cx="425116" cy="231315"/>
              <a:chOff x="5834676" y="6089139"/>
              <a:chExt cx="425116" cy="231315"/>
            </a:xfrm>
          </p:grpSpPr>
          <p:cxnSp>
            <p:nvCxnSpPr>
              <p:cNvPr id="20" name="Straight Connector 19"/>
              <p:cNvCxnSpPr/>
              <p:nvPr/>
            </p:nvCxnSpPr>
            <p:spPr>
              <a:xfrm>
                <a:off x="5975226" y="6320454"/>
                <a:ext cx="144016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5834676" y="608913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800" b="1" dirty="0">
                    <a:solidFill>
                      <a:schemeClr val="bg1"/>
                    </a:solidFill>
                  </a:rPr>
                  <a:t>25</a:t>
                </a:r>
                <a:r>
                  <a:rPr lang="el-GR" sz="800" b="1" dirty="0">
                    <a:solidFill>
                      <a:schemeClr val="bg1"/>
                    </a:solidFill>
                  </a:rPr>
                  <a:t>μ</a:t>
                </a:r>
                <a:r>
                  <a:rPr lang="en-IN" sz="800" b="1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</p:grpSp>
      <p:pic>
        <p:nvPicPr>
          <p:cNvPr id="1028" name="Picture 4" descr="D:\Sunita\25.04.18\New folder (3)\Sunita-31st Jan\Experiment-31.01.2018_3-4_z0_ch02.tif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0933" y="923727"/>
            <a:ext cx="14976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Sunita\25.04.18\New folder (3)\Sunita-31st Jan\Experiment-31.01.2018_3-4_z0_ch02.tif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8033" y="923727"/>
            <a:ext cx="14976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1700568" y="925538"/>
            <a:ext cx="762822" cy="234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720528" y="925538"/>
            <a:ext cx="762822" cy="234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chemeClr val="bg1"/>
                </a:solidFill>
              </a:rPr>
              <a:t>Merged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869998" y="1507039"/>
            <a:ext cx="1237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/>
              <a:t>Negative control</a:t>
            </a:r>
          </a:p>
        </p:txBody>
      </p:sp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6481" y="923727"/>
            <a:ext cx="1486800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61578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DA576E93-6DA3-8244-B5CF-B78BB9FEBC13}"/>
              </a:ext>
            </a:extLst>
          </p:cNvPr>
          <p:cNvGrpSpPr/>
          <p:nvPr/>
        </p:nvGrpSpPr>
        <p:grpSpPr>
          <a:xfrm>
            <a:off x="1726754" y="1695111"/>
            <a:ext cx="2409650" cy="1306193"/>
            <a:chOff x="1580289" y="3396965"/>
            <a:chExt cx="2967888" cy="1434730"/>
          </a:xfrm>
        </p:grpSpPr>
        <p:pic>
          <p:nvPicPr>
            <p:cNvPr id="3" name="Picture 2" descr="D:\Sunita\western blot\p32 cancer\gapdh.jpg">
              <a:extLst>
                <a:ext uri="{FF2B5EF4-FFF2-40B4-BE49-F238E27FC236}">
                  <a16:creationId xmlns:a16="http://schemas.microsoft.com/office/drawing/2014/main" xmlns="" id="{D1909E49-F5E3-0347-8070-01F05AE08E1D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48" t="59175" r="33672" b="31320"/>
            <a:stretch/>
          </p:blipFill>
          <p:spPr bwMode="auto">
            <a:xfrm>
              <a:off x="2254626" y="3871081"/>
              <a:ext cx="1349206" cy="3954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3" descr="D:\Sunita\western blot\p32 cancer\p32.jpg">
              <a:extLst>
                <a:ext uri="{FF2B5EF4-FFF2-40B4-BE49-F238E27FC236}">
                  <a16:creationId xmlns:a16="http://schemas.microsoft.com/office/drawing/2014/main" xmlns="" id="{FD71A2BA-4FD8-8045-AC41-7AD5A95D878F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1" t="67217" r="45834" b="22660"/>
            <a:stretch/>
          </p:blipFill>
          <p:spPr bwMode="auto">
            <a:xfrm>
              <a:off x="2254622" y="3396965"/>
              <a:ext cx="1349209" cy="39542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ABD5CF14-C5F6-0B44-A41B-31C11EB41020}"/>
                </a:ext>
              </a:extLst>
            </p:cNvPr>
            <p:cNvSpPr txBox="1"/>
            <p:nvPr/>
          </p:nvSpPr>
          <p:spPr>
            <a:xfrm rot="18931993">
              <a:off x="1580289" y="4494754"/>
              <a:ext cx="1121836" cy="30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SK-MEL-2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8F08A808-3356-2B4E-9528-F1954A42D90A}"/>
                </a:ext>
              </a:extLst>
            </p:cNvPr>
            <p:cNvSpPr txBox="1"/>
            <p:nvPr/>
          </p:nvSpPr>
          <p:spPr>
            <a:xfrm rot="18931993">
              <a:off x="2008758" y="4527438"/>
              <a:ext cx="1226476" cy="30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SK-MEL-28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400CB45E-C7E4-3F48-AA3C-55F702B1B4FF}"/>
                </a:ext>
              </a:extLst>
            </p:cNvPr>
            <p:cNvSpPr txBox="1"/>
            <p:nvPr/>
          </p:nvSpPr>
          <p:spPr>
            <a:xfrm rot="18931993">
              <a:off x="2872503" y="4355994"/>
              <a:ext cx="677603" cy="30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A37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B50E045E-CC89-A549-A3D2-F6A1BD57D2D8}"/>
                </a:ext>
              </a:extLst>
            </p:cNvPr>
            <p:cNvSpPr txBox="1"/>
            <p:nvPr/>
          </p:nvSpPr>
          <p:spPr>
            <a:xfrm>
              <a:off x="3637599" y="3400139"/>
              <a:ext cx="553218" cy="30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ea typeface="Arial" charset="0"/>
                  <a:cs typeface="Arial" pitchFamily="34" charset="0"/>
                </a:rPr>
                <a:t>p3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20BB1484-C30D-5548-8F0B-1726645F1909}"/>
                </a:ext>
              </a:extLst>
            </p:cNvPr>
            <p:cNvSpPr txBox="1"/>
            <p:nvPr/>
          </p:nvSpPr>
          <p:spPr>
            <a:xfrm>
              <a:off x="3637599" y="3871081"/>
              <a:ext cx="910578" cy="30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ea typeface="Arial" charset="0"/>
                  <a:cs typeface="Arial" pitchFamily="34" charset="0"/>
                </a:rPr>
                <a:t>GAPDH</a:t>
              </a:r>
            </a:p>
          </p:txBody>
        </p:sp>
      </p:grpSp>
      <p:pic>
        <p:nvPicPr>
          <p:cNvPr id="10" name="Picture 2" descr="D:\Sunita\Melanoma\p32 graph images\p32 in human.tif">
            <a:extLst>
              <a:ext uri="{FF2B5EF4-FFF2-40B4-BE49-F238E27FC236}">
                <a16:creationId xmlns:a16="http://schemas.microsoft.com/office/drawing/2014/main" xmlns="" id="{7E72DB78-89C5-2E4F-BC10-A697A36E36E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9612" y="3644660"/>
            <a:ext cx="2017668" cy="3617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1726754" y="1376527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4C98D69-0FE3-BE47-AB3F-758CFE51A9C3}"/>
              </a:ext>
            </a:extLst>
          </p:cNvPr>
          <p:cNvSpPr txBox="1"/>
          <p:nvPr/>
        </p:nvSpPr>
        <p:spPr>
          <a:xfrm>
            <a:off x="1726754" y="3680783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B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DED16DA8-0956-6F4A-8A6C-0474E9C4FE2B}"/>
              </a:ext>
            </a:extLst>
          </p:cNvPr>
          <p:cNvSpPr/>
          <p:nvPr/>
        </p:nvSpPr>
        <p:spPr>
          <a:xfrm>
            <a:off x="790650" y="7480007"/>
            <a:ext cx="64807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2. 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Immunoblot and densitometric analysis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relative mRNA expression levels of p32 i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K-MEL-2, SK-MEL-28 and A375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human melanoma cells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P &lt; 0.01, *P &lt;0.05).</a:t>
            </a:r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131DBB3-6FEC-8945-86A1-27577B49E463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2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1050" y="1014371"/>
            <a:ext cx="1292349" cy="20814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25272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4B59A6F3-44AE-C84E-B83E-B0D34489FDC3}"/>
              </a:ext>
            </a:extLst>
          </p:cNvPr>
          <p:cNvSpPr/>
          <p:nvPr/>
        </p:nvSpPr>
        <p:spPr>
          <a:xfrm>
            <a:off x="862658" y="6111855"/>
            <a:ext cx="6120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3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qPCR showing relative mRNA expression of oncogenes, CCND1 and MYC in SK-MEL-2, SK-MEL-28 and A375 cells. 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P &lt; 0.01, *P &lt;0.05).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D45F463-38F5-6D4B-AD4E-44F9812F0153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3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684750" y="2071871"/>
            <a:ext cx="5058884" cy="3174147"/>
            <a:chOff x="1684750" y="1999863"/>
            <a:chExt cx="5058884" cy="3174147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4E876973-29A9-644B-B734-A92E1F237B9A}"/>
                </a:ext>
              </a:extLst>
            </p:cNvPr>
            <p:cNvSpPr txBox="1"/>
            <p:nvPr/>
          </p:nvSpPr>
          <p:spPr>
            <a:xfrm>
              <a:off x="4513016" y="2470820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MY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D41237D2-A207-5F46-8BCC-EBE79D549C78}"/>
                </a:ext>
              </a:extLst>
            </p:cNvPr>
            <p:cNvSpPr txBox="1"/>
            <p:nvPr/>
          </p:nvSpPr>
          <p:spPr>
            <a:xfrm>
              <a:off x="2333709" y="2472835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CCND1</a:t>
              </a:r>
            </a:p>
          </p:txBody>
        </p:sp>
        <p:pic>
          <p:nvPicPr>
            <p:cNvPr id="22" name="Picture 10" descr="C:\Users\acer pc\Desktop\mmp9.tif">
              <a:extLst>
                <a:ext uri="{FF2B5EF4-FFF2-40B4-BE49-F238E27FC236}">
                  <a16:creationId xmlns:a16="http://schemas.microsoft.com/office/drawing/2014/main" xmlns="" id="{02237C8B-2F45-F146-BF26-EC0EE6E88E5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90" t="11193" b="53285"/>
            <a:stretch/>
          </p:blipFill>
          <p:spPr bwMode="auto">
            <a:xfrm>
              <a:off x="5451854" y="1999863"/>
              <a:ext cx="1291780" cy="83099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6232"/>
            <a:stretch/>
          </p:blipFill>
          <p:spPr bwMode="auto">
            <a:xfrm>
              <a:off x="1684750" y="2830860"/>
              <a:ext cx="1556894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591"/>
            <a:stretch/>
          </p:blipFill>
          <p:spPr bwMode="auto">
            <a:xfrm>
              <a:off x="3742978" y="2830860"/>
              <a:ext cx="1575470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63174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4B59A6F3-44AE-C84E-B83E-B0D34489FDC3}"/>
              </a:ext>
            </a:extLst>
          </p:cNvPr>
          <p:cNvSpPr/>
          <p:nvPr/>
        </p:nvSpPr>
        <p:spPr>
          <a:xfrm>
            <a:off x="718642" y="7151325"/>
            <a:ext cx="64807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4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qPCR showing relative mRNA expression of epithelial marker (E-cadherin) and mesenchymal markers (vimentin, twist, snail, MMP-2 and MMP-9) in SK-MEL-2, SK-MEL-28 and A375 cells. 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*P &lt; 0.001, **P &lt; 0.01, *P &lt;0.05).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D45F463-38F5-6D4B-AD4E-44F9812F0153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4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907383" y="1259721"/>
            <a:ext cx="6267621" cy="5498465"/>
            <a:chOff x="907383" y="828731"/>
            <a:chExt cx="6267621" cy="549846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703"/>
            <a:stretch/>
          </p:blipFill>
          <p:spPr bwMode="auto">
            <a:xfrm>
              <a:off x="5443887" y="1146024"/>
              <a:ext cx="1572225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189"/>
            <a:stretch/>
          </p:blipFill>
          <p:spPr bwMode="auto">
            <a:xfrm>
              <a:off x="3856788" y="1146024"/>
              <a:ext cx="1587099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486"/>
            <a:stretch/>
          </p:blipFill>
          <p:spPr bwMode="auto">
            <a:xfrm>
              <a:off x="2336186" y="1146024"/>
              <a:ext cx="1520602" cy="2362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486"/>
            <a:stretch/>
          </p:blipFill>
          <p:spPr bwMode="auto">
            <a:xfrm>
              <a:off x="907383" y="1146024"/>
              <a:ext cx="1520602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8B0D60A8-4353-3F40-8317-091AA8B66FD2}"/>
                </a:ext>
              </a:extLst>
            </p:cNvPr>
            <p:cNvSpPr txBox="1"/>
            <p:nvPr/>
          </p:nvSpPr>
          <p:spPr>
            <a:xfrm>
              <a:off x="3022898" y="82873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VIM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B4F393A5-0809-4649-817C-801A47BE8ADF}"/>
                </a:ext>
              </a:extLst>
            </p:cNvPr>
            <p:cNvSpPr txBox="1"/>
            <p:nvPr/>
          </p:nvSpPr>
          <p:spPr>
            <a:xfrm>
              <a:off x="4650337" y="828731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CCND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F133E635-BF1D-474F-A5CE-27ACA8991AA7}"/>
                </a:ext>
              </a:extLst>
            </p:cNvPr>
            <p:cNvSpPr txBox="1"/>
            <p:nvPr/>
          </p:nvSpPr>
          <p:spPr>
            <a:xfrm>
              <a:off x="6167470" y="828731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 smtClean="0">
                  <a:latin typeface="Arial" pitchFamily="34" charset="0"/>
                  <a:cs typeface="Arial" pitchFamily="34" charset="0"/>
                </a:rPr>
                <a:t>SNAIL</a:t>
              </a:r>
              <a:endParaRPr lang="en-IN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8B0D60A8-4353-3F40-8317-091AA8B66FD2}"/>
                </a:ext>
              </a:extLst>
            </p:cNvPr>
            <p:cNvSpPr txBox="1"/>
            <p:nvPr/>
          </p:nvSpPr>
          <p:spPr>
            <a:xfrm>
              <a:off x="1629363" y="828731"/>
              <a:ext cx="60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CDH1</a:t>
              </a: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9404" y="3917371"/>
              <a:ext cx="2895600" cy="2409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486"/>
            <a:stretch/>
          </p:blipFill>
          <p:spPr bwMode="auto">
            <a:xfrm>
              <a:off x="2726432" y="3917371"/>
              <a:ext cx="1520602" cy="2409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486"/>
            <a:stretch/>
          </p:blipFill>
          <p:spPr bwMode="auto">
            <a:xfrm>
              <a:off x="1142256" y="3917371"/>
              <a:ext cx="1520602" cy="2343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78C4444D-A28B-CB42-B39F-27B8BD44E028}"/>
                </a:ext>
              </a:extLst>
            </p:cNvPr>
            <p:cNvSpPr txBox="1"/>
            <p:nvPr/>
          </p:nvSpPr>
          <p:spPr>
            <a:xfrm>
              <a:off x="1851312" y="3734021"/>
              <a:ext cx="7505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TWIST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7579F652-030B-7049-9BB1-3B04A33782C7}"/>
                </a:ext>
              </a:extLst>
            </p:cNvPr>
            <p:cNvSpPr txBox="1"/>
            <p:nvPr/>
          </p:nvSpPr>
          <p:spPr>
            <a:xfrm>
              <a:off x="3592688" y="3734021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MMP-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073C8DE4-FD1A-644E-BF1A-F13A7221968A}"/>
                </a:ext>
              </a:extLst>
            </p:cNvPr>
            <p:cNvSpPr txBox="1"/>
            <p:nvPr/>
          </p:nvSpPr>
          <p:spPr>
            <a:xfrm>
              <a:off x="5104856" y="3734021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200" b="1" dirty="0">
                  <a:latin typeface="Arial" pitchFamily="34" charset="0"/>
                  <a:cs typeface="Arial" pitchFamily="34" charset="0"/>
                </a:rPr>
                <a:t>MMP-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9572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2371462" y="1005548"/>
            <a:ext cx="2795570" cy="1786316"/>
            <a:chOff x="574625" y="637506"/>
            <a:chExt cx="2795570" cy="1786316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1EC5B7DF-3FDC-B64C-8671-9C6CAC926E77}"/>
                </a:ext>
              </a:extLst>
            </p:cNvPr>
            <p:cNvSpPr txBox="1"/>
            <p:nvPr/>
          </p:nvSpPr>
          <p:spPr>
            <a:xfrm>
              <a:off x="1719873" y="637506"/>
              <a:ext cx="6383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000" b="1" dirty="0">
                  <a:latin typeface="Arial" pitchFamily="34" charset="0"/>
                  <a:ea typeface="Arial" charset="0"/>
                  <a:cs typeface="Arial" pitchFamily="34" charset="0"/>
                </a:rPr>
                <a:t>B16F10</a:t>
              </a:r>
            </a:p>
          </p:txBody>
        </p: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xmlns="" id="{1DF2C626-4783-6940-894F-EE59438801B3}"/>
                </a:ext>
              </a:extLst>
            </p:cNvPr>
            <p:cNvCxnSpPr/>
            <p:nvPr/>
          </p:nvCxnSpPr>
          <p:spPr>
            <a:xfrm>
              <a:off x="1690701" y="882437"/>
              <a:ext cx="6549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Group 5"/>
            <p:cNvGrpSpPr/>
            <p:nvPr/>
          </p:nvGrpSpPr>
          <p:grpSpPr>
            <a:xfrm>
              <a:off x="574625" y="1131704"/>
              <a:ext cx="1395122" cy="1292118"/>
              <a:chOff x="207481" y="1207362"/>
              <a:chExt cx="2456002" cy="236216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562708" y="1207362"/>
                <a:ext cx="2100775" cy="2362160"/>
                <a:chOff x="562708" y="1207362"/>
                <a:chExt cx="2100775" cy="2362160"/>
              </a:xfrm>
            </p:grpSpPr>
            <p:pic>
              <p:nvPicPr>
                <p:cNvPr id="9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748" t="12013" r="15864" b="25962"/>
                <a:stretch/>
              </p:blipFill>
              <p:spPr bwMode="auto">
                <a:xfrm>
                  <a:off x="562708" y="1207362"/>
                  <a:ext cx="2100775" cy="190628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904383" y="3119398"/>
                  <a:ext cx="1425654" cy="4501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sz="1000" b="1" dirty="0" err="1">
                      <a:latin typeface="Arial" pitchFamily="34" charset="0"/>
                      <a:cs typeface="Arial" pitchFamily="34" charset="0"/>
                    </a:rPr>
                    <a:t>Annexin</a:t>
                  </a:r>
                  <a:r>
                    <a:rPr lang="en-IN" sz="1000" b="1" dirty="0">
                      <a:latin typeface="Arial" pitchFamily="34" charset="0"/>
                      <a:cs typeface="Arial" pitchFamily="34" charset="0"/>
                    </a:rPr>
                    <a:t> V</a:t>
                  </a: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 rot="16200000">
                <a:off x="145517" y="2085155"/>
                <a:ext cx="557382" cy="433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PI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969747" y="1131704"/>
              <a:ext cx="1400448" cy="1291474"/>
              <a:chOff x="2716221" y="1208534"/>
              <a:chExt cx="2465379" cy="2360986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3071446" y="1208534"/>
                <a:ext cx="2110154" cy="2360986"/>
                <a:chOff x="3071446" y="1208534"/>
                <a:chExt cx="2110154" cy="2360986"/>
              </a:xfrm>
            </p:grpSpPr>
            <p:pic>
              <p:nvPicPr>
                <p:cNvPr id="14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748" t="12207" r="15548" b="25695"/>
                <a:stretch/>
              </p:blipFill>
              <p:spPr bwMode="auto">
                <a:xfrm>
                  <a:off x="3071446" y="1208534"/>
                  <a:ext cx="2110154" cy="190851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5" name="TextBox 14"/>
                <p:cNvSpPr txBox="1"/>
                <p:nvPr/>
              </p:nvSpPr>
              <p:spPr>
                <a:xfrm>
                  <a:off x="3406898" y="3119395"/>
                  <a:ext cx="1425655" cy="4501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sz="1000" b="1" dirty="0" err="1">
                      <a:latin typeface="Arial" pitchFamily="34" charset="0"/>
                      <a:cs typeface="Arial" pitchFamily="34" charset="0"/>
                    </a:rPr>
                    <a:t>Annexin</a:t>
                  </a:r>
                  <a:r>
                    <a:rPr lang="en-IN" sz="1000" b="1" dirty="0">
                      <a:latin typeface="Arial" pitchFamily="34" charset="0"/>
                      <a:cs typeface="Arial" pitchFamily="34" charset="0"/>
                    </a:rPr>
                    <a:t> V</a:t>
                  </a:r>
                </a:p>
              </p:txBody>
            </p:sp>
          </p:grpSp>
          <p:sp>
            <p:nvSpPr>
              <p:cNvPr id="13" name="TextBox 12"/>
              <p:cNvSpPr txBox="1"/>
              <p:nvPr/>
            </p:nvSpPr>
            <p:spPr>
              <a:xfrm rot="16200000">
                <a:off x="2654256" y="2085741"/>
                <a:ext cx="557383" cy="433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PI</a:t>
                </a: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950818" y="888128"/>
              <a:ext cx="888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ea typeface="Arial" charset="0"/>
                  <a:cs typeface="Arial" panose="020B0604020202020204" pitchFamily="34" charset="0"/>
                </a:rPr>
                <a:t>Ctrl shRNA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21596" y="882437"/>
              <a:ext cx="8929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b="1" dirty="0">
                  <a:latin typeface="Arial" pitchFamily="34" charset="0"/>
                  <a:ea typeface="Arial" charset="0"/>
                  <a:cs typeface="Arial" panose="020B0604020202020204" pitchFamily="34" charset="0"/>
                </a:rPr>
                <a:t>p32 shRNA</a:t>
              </a:r>
              <a:endParaRPr lang="en-IN" sz="1000" b="1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405570" y="2994140"/>
            <a:ext cx="2781954" cy="1798001"/>
            <a:chOff x="3886993" y="637506"/>
            <a:chExt cx="2781954" cy="179800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1511E706-A2D9-1D4A-BB01-6ADD6F04AA6A}"/>
                </a:ext>
              </a:extLst>
            </p:cNvPr>
            <p:cNvSpPr txBox="1"/>
            <p:nvPr/>
          </p:nvSpPr>
          <p:spPr>
            <a:xfrm>
              <a:off x="5119806" y="637506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000" b="1" dirty="0">
                  <a:latin typeface="Arial" pitchFamily="34" charset="0"/>
                  <a:ea typeface="Arial" charset="0"/>
                  <a:cs typeface="Arial" pitchFamily="34" charset="0"/>
                </a:rPr>
                <a:t>A375</a:t>
              </a:r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41E1CAD9-BE57-254A-A31F-0388ECE7E054}"/>
                </a:ext>
              </a:extLst>
            </p:cNvPr>
            <p:cNvCxnSpPr/>
            <p:nvPr/>
          </p:nvCxnSpPr>
          <p:spPr>
            <a:xfrm>
              <a:off x="5050942" y="882437"/>
              <a:ext cx="6549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Group 15"/>
            <p:cNvGrpSpPr/>
            <p:nvPr/>
          </p:nvGrpSpPr>
          <p:grpSpPr>
            <a:xfrm>
              <a:off x="3886993" y="1131703"/>
              <a:ext cx="1409777" cy="1303804"/>
              <a:chOff x="193060" y="3962400"/>
              <a:chExt cx="2481803" cy="2383528"/>
            </a:xfrm>
          </p:grpSpPr>
          <p:pic>
            <p:nvPicPr>
              <p:cNvPr id="17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16" t="11960" r="15532" b="25916"/>
              <a:stretch/>
            </p:blipFill>
            <p:spPr bwMode="auto">
              <a:xfrm>
                <a:off x="551327" y="3962400"/>
                <a:ext cx="2123536" cy="19093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891451" y="5895803"/>
                <a:ext cx="1425656" cy="4501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 err="1">
                    <a:latin typeface="Arial" pitchFamily="34" charset="0"/>
                    <a:cs typeface="Arial" pitchFamily="34" charset="0"/>
                  </a:rPr>
                  <a:t>Annexin</a:t>
                </a:r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 V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131095" y="4861560"/>
                <a:ext cx="557383" cy="433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PI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5286760" y="1141989"/>
              <a:ext cx="1382187" cy="1281192"/>
              <a:chOff x="2617403" y="3962400"/>
              <a:chExt cx="2433233" cy="2342186"/>
            </a:xfrm>
          </p:grpSpPr>
          <p:pic>
            <p:nvPicPr>
              <p:cNvPr id="21" name="Picture 3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59" t="12521" r="15793" b="25916"/>
              <a:stretch/>
            </p:blipFill>
            <p:spPr bwMode="auto">
              <a:xfrm>
                <a:off x="2963044" y="3962400"/>
                <a:ext cx="2087592" cy="18920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3390476" y="5854462"/>
                <a:ext cx="1425656" cy="4501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 err="1">
                    <a:latin typeface="Arial" pitchFamily="34" charset="0"/>
                    <a:cs typeface="Arial" pitchFamily="34" charset="0"/>
                  </a:rPr>
                  <a:t>Annexin</a:t>
                </a:r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 V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2555439" y="4820803"/>
                <a:ext cx="557382" cy="433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sz="1000" b="1" dirty="0">
                    <a:latin typeface="Arial" pitchFamily="34" charset="0"/>
                    <a:cs typeface="Arial" pitchFamily="34" charset="0"/>
                  </a:rPr>
                  <a:t>PI</a:t>
                </a: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4251015" y="906044"/>
              <a:ext cx="888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ea typeface="Arial" charset="0"/>
                  <a:cs typeface="Arial" panose="020B0604020202020204" pitchFamily="34" charset="0"/>
                </a:rPr>
                <a:t>Ctrl shRNA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621793" y="900352"/>
              <a:ext cx="8929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b="1" dirty="0">
                  <a:latin typeface="Arial" pitchFamily="34" charset="0"/>
                  <a:ea typeface="Arial" charset="0"/>
                  <a:cs typeface="Arial" panose="020B0604020202020204" pitchFamily="34" charset="0"/>
                </a:rPr>
                <a:t>p32 shRNA</a:t>
              </a:r>
              <a:endParaRPr lang="en-IN" sz="1000" b="1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A6892605-5B58-45EF-ACC6-CD2B14B41540}"/>
              </a:ext>
            </a:extLst>
          </p:cNvPr>
          <p:cNvSpPr txBox="1"/>
          <p:nvPr/>
        </p:nvSpPr>
        <p:spPr>
          <a:xfrm>
            <a:off x="422897" y="8447469"/>
            <a:ext cx="70567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5.  (A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Evaluation by flow cytometry of Annexin V-FITC/PI double staining in B16F10 and A375 cells treated with control shRNA and p32 shRNA .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B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Immunoblot analysis of PARP 1, Cleaved caspase -9 and GAPDH in B16F10 and A375 melanoma cells treated with control shRNA and p32 shRNA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3 (*P &lt;0.05).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1689955" y="1081202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84C98D69-0FE3-BE47-AB3F-758CFE51A9C3}"/>
              </a:ext>
            </a:extLst>
          </p:cNvPr>
          <p:cNvSpPr txBox="1"/>
          <p:nvPr/>
        </p:nvSpPr>
        <p:spPr>
          <a:xfrm>
            <a:off x="305536" y="5483528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B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5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55" t="3379" b="80821"/>
          <a:stretch/>
        </p:blipFill>
        <p:spPr bwMode="auto">
          <a:xfrm>
            <a:off x="6297681" y="5483528"/>
            <a:ext cx="1116124" cy="383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8" name="Group 57"/>
          <p:cNvGrpSpPr/>
          <p:nvPr/>
        </p:nvGrpSpPr>
        <p:grpSpPr>
          <a:xfrm>
            <a:off x="142578" y="5929507"/>
            <a:ext cx="3503119" cy="1737136"/>
            <a:chOff x="646169" y="5929507"/>
            <a:chExt cx="3503119" cy="1737136"/>
          </a:xfrm>
        </p:grpSpPr>
        <p:grpSp>
          <p:nvGrpSpPr>
            <p:cNvPr id="49" name="Group 48"/>
            <p:cNvGrpSpPr/>
            <p:nvPr/>
          </p:nvGrpSpPr>
          <p:grpSpPr>
            <a:xfrm>
              <a:off x="1006674" y="5929507"/>
              <a:ext cx="3142614" cy="1737136"/>
              <a:chOff x="1641040" y="3256149"/>
              <a:chExt cx="3142614" cy="1737136"/>
            </a:xfrm>
          </p:grpSpPr>
          <p:grpSp>
            <p:nvGrpSpPr>
              <p:cNvPr id="36" name="Group 35"/>
              <p:cNvGrpSpPr/>
              <p:nvPr/>
            </p:nvGrpSpPr>
            <p:grpSpPr>
              <a:xfrm>
                <a:off x="2461043" y="3570538"/>
                <a:ext cx="1690186" cy="881860"/>
                <a:chOff x="2675576" y="2838454"/>
                <a:chExt cx="1690186" cy="881860"/>
              </a:xfrm>
            </p:grpSpPr>
            <p:pic>
              <p:nvPicPr>
                <p:cNvPr id="30" name="Picture 2" descr="C:\Users\acer pc\Desktop\blots\gapdh.jpg"/>
                <p:cNvPicPr preferRelativeResize="0">
                  <a:picLocks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406" t="58263" r="67962" b="35342"/>
                <a:stretch/>
              </p:blipFill>
              <p:spPr bwMode="auto">
                <a:xfrm>
                  <a:off x="2675576" y="3468314"/>
                  <a:ext cx="766800" cy="252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1" name="Picture 3"/>
                <p:cNvPicPr preferRelativeResize="0">
                  <a:picLocks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733" t="32973" r="63489" b="57733"/>
                <a:stretch/>
              </p:blipFill>
              <p:spPr bwMode="auto">
                <a:xfrm>
                  <a:off x="2675576" y="2838454"/>
                  <a:ext cx="766800" cy="252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2" name="Picture 2" descr="C:\Users\acer pc\Desktop\blots\gapdh.jpg"/>
                <p:cNvPicPr preferRelativeResize="0">
                  <a:picLocks noChangeArrowheads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3553" t="58082" r="30722" b="35712"/>
                <a:stretch/>
              </p:blipFill>
              <p:spPr bwMode="auto">
                <a:xfrm>
                  <a:off x="3598962" y="3468314"/>
                  <a:ext cx="766800" cy="252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3" name="Picture 3"/>
                <p:cNvPicPr preferRelativeResize="0">
                  <a:picLocks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747" t="32973" r="30750" b="57733"/>
                <a:stretch/>
              </p:blipFill>
              <p:spPr bwMode="auto">
                <a:xfrm>
                  <a:off x="3598962" y="2838454"/>
                  <a:ext cx="766800" cy="252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4" name="Picture 4" descr="C:\Users\acer pc\Desktop\blots\cleaved caspase 9.jpg"/>
                <p:cNvPicPr preferRelativeResize="0">
                  <a:picLocks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800" t="50466" r="10986" b="40753"/>
                <a:stretch/>
              </p:blipFill>
              <p:spPr bwMode="auto">
                <a:xfrm>
                  <a:off x="3598962" y="3157786"/>
                  <a:ext cx="766800" cy="252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5" name="Picture 4" descr="C:\Users\acer pc\Desktop\blots\cleaved caspase 9.jpg"/>
                <p:cNvPicPr preferRelativeResize="0">
                  <a:picLocks noChangeArrowheads="1"/>
                </p:cNvPicPr>
                <p:nvPr/>
              </p:nvPicPr>
              <p:blipFill rotWithShape="1"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576" t="50529" r="66433" b="40753"/>
                <a:stretch/>
              </p:blipFill>
              <p:spPr bwMode="auto">
                <a:xfrm>
                  <a:off x="2675576" y="3153384"/>
                  <a:ext cx="766800" cy="252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37" name="TextBox 36"/>
              <p:cNvSpPr txBox="1"/>
              <p:nvPr/>
            </p:nvSpPr>
            <p:spPr>
              <a:xfrm rot="19091440">
                <a:off x="1928099" y="4738647"/>
                <a:ext cx="8691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Ctrl </a:t>
                </a:r>
                <a:r>
                  <a:rPr lang="en-IN" sz="1000" b="1" dirty="0" err="1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shRNA</a:t>
                </a:r>
                <a:endParaRPr lang="en-IN" sz="10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9169232">
                <a:off x="2292337" y="4747064"/>
                <a:ext cx="8675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p32 shRNA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9091440">
                <a:off x="2871561" y="4738647"/>
                <a:ext cx="8691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Ctrl </a:t>
                </a:r>
                <a:r>
                  <a:rPr lang="en-IN" sz="1000" b="1" dirty="0" err="1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shRNA</a:t>
                </a:r>
                <a:endParaRPr lang="en-IN" sz="10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9169232">
                <a:off x="3235799" y="4747062"/>
                <a:ext cx="8675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p32 shRNA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xmlns="" id="{1EC5B7DF-3FDC-B64C-8671-9C6CAC926E77}"/>
                  </a:ext>
                </a:extLst>
              </p:cNvPr>
              <p:cNvSpPr txBox="1"/>
              <p:nvPr/>
            </p:nvSpPr>
            <p:spPr>
              <a:xfrm>
                <a:off x="2516966" y="3256150"/>
                <a:ext cx="6383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itchFamily="34" charset="0"/>
                    <a:ea typeface="Arial" charset="0"/>
                    <a:cs typeface="Arial" pitchFamily="34" charset="0"/>
                  </a:rPr>
                  <a:t>B16F1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1511E706-A2D9-1D4A-BB01-6ADD6F04AA6A}"/>
                  </a:ext>
                </a:extLst>
              </p:cNvPr>
              <p:cNvSpPr txBox="1"/>
              <p:nvPr/>
            </p:nvSpPr>
            <p:spPr>
              <a:xfrm>
                <a:off x="3516835" y="3256149"/>
                <a:ext cx="4892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itchFamily="34" charset="0"/>
                    <a:ea typeface="Arial" charset="0"/>
                    <a:cs typeface="Arial" pitchFamily="34" charset="0"/>
                  </a:rPr>
                  <a:t>A37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xmlns="" id="{D4DD6202-A3A1-0D4C-80D4-35DD7B29BB3A}"/>
                  </a:ext>
                </a:extLst>
              </p:cNvPr>
              <p:cNvSpPr txBox="1"/>
              <p:nvPr/>
            </p:nvSpPr>
            <p:spPr>
              <a:xfrm>
                <a:off x="4153353" y="4205115"/>
                <a:ext cx="5597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37kDa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xmlns="" id="{E1C248EF-BD2F-6D4F-9EC2-646D22CF7BA4}"/>
                  </a:ext>
                </a:extLst>
              </p:cNvPr>
              <p:cNvSpPr txBox="1"/>
              <p:nvPr/>
            </p:nvSpPr>
            <p:spPr>
              <a:xfrm>
                <a:off x="4153353" y="3923837"/>
                <a:ext cx="5597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37kDa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xmlns="" id="{E1C248EF-BD2F-6D4F-9EC2-646D22CF7BA4}"/>
                  </a:ext>
                </a:extLst>
              </p:cNvPr>
              <p:cNvSpPr txBox="1"/>
              <p:nvPr/>
            </p:nvSpPr>
            <p:spPr>
              <a:xfrm>
                <a:off x="4153353" y="3570537"/>
                <a:ext cx="6303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130kDa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xmlns="" id="{ADEBAE29-0C18-429F-AD77-BA9404301606}"/>
                  </a:ext>
                </a:extLst>
              </p:cNvPr>
              <p:cNvSpPr txBox="1"/>
              <p:nvPr/>
            </p:nvSpPr>
            <p:spPr>
              <a:xfrm>
                <a:off x="1641040" y="3819648"/>
                <a:ext cx="80021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Cleaved </a:t>
                </a:r>
              </a:p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caspase-9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xmlns="" id="{4333AB86-45F2-4A90-B8D3-6B7E91761ACD}"/>
                  </a:ext>
                </a:extLst>
              </p:cNvPr>
              <p:cNvSpPr txBox="1"/>
              <p:nvPr/>
            </p:nvSpPr>
            <p:spPr>
              <a:xfrm>
                <a:off x="1687732" y="4252462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GAPDH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xmlns="" id="{5F4CAAAA-23B7-4B8F-A8A0-680548C0C83F}"/>
                  </a:ext>
                </a:extLst>
              </p:cNvPr>
              <p:cNvSpPr txBox="1"/>
              <p:nvPr/>
            </p:nvSpPr>
            <p:spPr>
              <a:xfrm>
                <a:off x="1806149" y="3436756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PARP</a:t>
                </a:r>
              </a:p>
            </p:txBody>
          </p: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668FF37F-7768-E149-B7FE-79415AA0B4D7}"/>
                </a:ext>
              </a:extLst>
            </p:cNvPr>
            <p:cNvSpPr txBox="1"/>
            <p:nvPr/>
          </p:nvSpPr>
          <p:spPr>
            <a:xfrm>
              <a:off x="646169" y="6297743"/>
              <a:ext cx="10647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IN" sz="1000" b="1" dirty="0">
                  <a:latin typeface="Arial" charset="0"/>
                  <a:ea typeface="Arial" charset="0"/>
                  <a:cs typeface="Arial" charset="0"/>
                </a:rPr>
                <a:t>Cleaved PARP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3742978" y="5929683"/>
            <a:ext cx="3936834" cy="2196655"/>
            <a:chOff x="3766584" y="5660600"/>
            <a:chExt cx="3936834" cy="219665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9" r="41165"/>
            <a:stretch/>
          </p:blipFill>
          <p:spPr bwMode="auto">
            <a:xfrm>
              <a:off x="6321287" y="5660600"/>
              <a:ext cx="1382131" cy="21966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0" r="41164"/>
            <a:stretch/>
          </p:blipFill>
          <p:spPr bwMode="auto">
            <a:xfrm>
              <a:off x="3766584" y="5660600"/>
              <a:ext cx="1357709" cy="21966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2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13" r="43676"/>
            <a:stretch/>
          </p:blipFill>
          <p:spPr bwMode="auto">
            <a:xfrm>
              <a:off x="5089304" y="5660600"/>
              <a:ext cx="1266973" cy="219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9791984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67B0E48-4597-0C45-BFF8-A13BD4D5FBB1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6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8A6A7388-C508-A549-8393-593BEDCC0FFB}"/>
              </a:ext>
            </a:extLst>
          </p:cNvPr>
          <p:cNvSpPr/>
          <p:nvPr/>
        </p:nvSpPr>
        <p:spPr>
          <a:xfrm>
            <a:off x="850714" y="8447469"/>
            <a:ext cx="648072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6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nsitometric analysis of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cogenes (C-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yc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nd Cyclin d1) and EMT markers matrix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etalloprotein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(E-cadherin, N-Cadherin, Fibronectin, Vimentin, Snail, Twist, MMP-2 and MMP-9)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n ctrl shRNA and p32 shRNA treated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murine and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uman melanoma cells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*P &lt; 0.001, **P &lt; 0.01, *P &lt;0.05)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IN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1265D43-B78D-0943-90C3-710FDBC07013}"/>
              </a:ext>
            </a:extLst>
          </p:cNvPr>
          <p:cNvSpPr txBox="1"/>
          <p:nvPr/>
        </p:nvSpPr>
        <p:spPr>
          <a:xfrm>
            <a:off x="1654746" y="853530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CFD44D0F-8EA2-5044-B4EE-7B446B158461}"/>
              </a:ext>
            </a:extLst>
          </p:cNvPr>
          <p:cNvSpPr txBox="1"/>
          <p:nvPr/>
        </p:nvSpPr>
        <p:spPr>
          <a:xfrm>
            <a:off x="1654746" y="4453930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B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3836" y="739832"/>
            <a:ext cx="4124325" cy="4048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3836" y="4750342"/>
            <a:ext cx="4562475" cy="3667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1400D37-A801-A94A-B5BF-3334D489B23E}"/>
              </a:ext>
            </a:extLst>
          </p:cNvPr>
          <p:cNvSpPr txBox="1"/>
          <p:nvPr/>
        </p:nvSpPr>
        <p:spPr>
          <a:xfrm>
            <a:off x="4007718" y="501874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16F1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2A4F4927-1ABD-7E4B-9477-A6F062FDF1C6}"/>
              </a:ext>
            </a:extLst>
          </p:cNvPr>
          <p:cNvSpPr txBox="1"/>
          <p:nvPr/>
        </p:nvSpPr>
        <p:spPr>
          <a:xfrm>
            <a:off x="4091074" y="461184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</a:p>
        </p:txBody>
      </p:sp>
    </p:spTree>
    <p:extLst>
      <p:ext uri="{BB962C8B-B14F-4D97-AF65-F5344CB8AC3E}">
        <p14:creationId xmlns:p14="http://schemas.microsoft.com/office/powerpoint/2010/main" val="2557710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46634" y="1480983"/>
            <a:ext cx="6288959" cy="4055733"/>
            <a:chOff x="1729681" y="1160600"/>
            <a:chExt cx="6288959" cy="4055733"/>
          </a:xfrm>
        </p:grpSpPr>
        <p:pic>
          <p:nvPicPr>
            <p:cNvPr id="4" name="Picture 5" descr="D:\Sunita\MD MC7 WB ONCOGENES\akt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02" r="43103"/>
            <a:stretch/>
          </p:blipFill>
          <p:spPr bwMode="auto">
            <a:xfrm>
              <a:off x="1729681" y="1541259"/>
              <a:ext cx="1969292" cy="36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6" descr="D:\Sunita\MD MC7 WB ONCOGENES\perk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64" r="48075"/>
            <a:stretch/>
          </p:blipFill>
          <p:spPr bwMode="auto">
            <a:xfrm>
              <a:off x="3833972" y="1613267"/>
              <a:ext cx="2000165" cy="36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8" descr="D:\Sunita\MD MC7 WB ONCOGENES\p38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24" r="42999"/>
            <a:stretch/>
          </p:blipFill>
          <p:spPr bwMode="auto">
            <a:xfrm>
              <a:off x="5936675" y="1616333"/>
              <a:ext cx="2081965" cy="36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9" descr="D:\Sunita\MD MC7 WB ONCOGENES\pgsk3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602" b="77420"/>
            <a:stretch/>
          </p:blipFill>
          <p:spPr bwMode="auto">
            <a:xfrm>
              <a:off x="6303640" y="1160600"/>
              <a:ext cx="1546721" cy="7158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0" name="TextBox 9"/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7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F177D5D2-CF97-0F45-8794-25599E389A3D}"/>
              </a:ext>
            </a:extLst>
          </p:cNvPr>
          <p:cNvSpPr/>
          <p:nvPr/>
        </p:nvSpPr>
        <p:spPr>
          <a:xfrm>
            <a:off x="718642" y="6546668"/>
            <a:ext cx="64807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 S7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nsitometric analysis of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-AKT, p-ERK and p-p38 in ctrl shRNA and p32 shRNA treated mouse and human melanoma cells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=3 (**P &lt; 0.01, *P &lt;0.05).</a:t>
            </a:r>
            <a:endParaRPr lang="en-IN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3448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49068A38-7541-493F-BAE2-ED39AC6C6FCF}"/>
              </a:ext>
            </a:extLst>
          </p:cNvPr>
          <p:cNvSpPr txBox="1"/>
          <p:nvPr/>
        </p:nvSpPr>
        <p:spPr>
          <a:xfrm>
            <a:off x="440145" y="8438177"/>
            <a:ext cx="705678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8  (A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Immunoblot analysis showing the expression level of </a:t>
            </a:r>
            <a:r>
              <a:rPr lang="en-IN" sz="1200" dirty="0" err="1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AKT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in  B16F10 and A375 cells with and without PKB  inhibitor;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B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Bar graphs show relative mRNA expression of EMT markers and oncogenes in control shRNA and p32 shRNA B16F10 cells treated with LY294002;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(C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Bar graphs show relative mRNA expression of EMT markers and oncogenes in control shRNA and p32 shRNA A375 cells treated with LY294002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*P &lt; 0.001, **P &lt; 0.01, *P &lt;0.05).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17D8CB9-D1E7-4FAF-9937-CC5EFC0ADB60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8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726355" y="858338"/>
            <a:ext cx="3960440" cy="2013238"/>
            <a:chOff x="358602" y="1752080"/>
            <a:chExt cx="3960440" cy="2013238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EF90EA87-6BA4-4681-B106-CEF78AE96118}"/>
                </a:ext>
              </a:extLst>
            </p:cNvPr>
            <p:cNvSpPr txBox="1"/>
            <p:nvPr/>
          </p:nvSpPr>
          <p:spPr>
            <a:xfrm>
              <a:off x="3280692" y="2051184"/>
              <a:ext cx="10383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LY294002</a:t>
              </a:r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358602" y="1752080"/>
              <a:ext cx="3539700" cy="2013238"/>
              <a:chOff x="2022449" y="1752080"/>
              <a:chExt cx="3539700" cy="2013238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xmlns="" id="{6E57200E-C1AB-4774-B787-E19A7CDFDFF7}"/>
                  </a:ext>
                </a:extLst>
              </p:cNvPr>
              <p:cNvGrpSpPr/>
              <p:nvPr/>
            </p:nvGrpSpPr>
            <p:grpSpPr>
              <a:xfrm>
                <a:off x="2022449" y="1752080"/>
                <a:ext cx="3539700" cy="1066551"/>
                <a:chOff x="2022449" y="1752080"/>
                <a:chExt cx="3539700" cy="1066551"/>
              </a:xfrm>
            </p:grpSpPr>
            <p:pic>
              <p:nvPicPr>
                <p:cNvPr id="6" name="Picture 3">
                  <a:extLst>
                    <a:ext uri="{FF2B5EF4-FFF2-40B4-BE49-F238E27FC236}">
                      <a16:creationId xmlns:a16="http://schemas.microsoft.com/office/drawing/2014/main" xmlns="" id="{4A1A8B66-F088-40E7-9921-93D5ACD325B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80333" y="2305761"/>
                  <a:ext cx="1173162" cy="20955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7" name="Picture 4">
                  <a:extLst>
                    <a:ext uri="{FF2B5EF4-FFF2-40B4-BE49-F238E27FC236}">
                      <a16:creationId xmlns:a16="http://schemas.microsoft.com/office/drawing/2014/main" xmlns="" id="{F38BD221-EB69-40B3-B846-0442653CB38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80333" y="2552554"/>
                  <a:ext cx="1163637" cy="24519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" name="Picture 8">
                  <a:extLst>
                    <a:ext uri="{FF2B5EF4-FFF2-40B4-BE49-F238E27FC236}">
                      <a16:creationId xmlns:a16="http://schemas.microsoft.com/office/drawing/2014/main" xmlns="" id="{8CADEBC0-C95F-4216-8139-5DF31ACF1C6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814012" y="2552018"/>
                  <a:ext cx="1201738" cy="26661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" name="Picture 9">
                  <a:extLst>
                    <a:ext uri="{FF2B5EF4-FFF2-40B4-BE49-F238E27FC236}">
                      <a16:creationId xmlns:a16="http://schemas.microsoft.com/office/drawing/2014/main" xmlns="" id="{E335420B-539B-4CAA-A84A-8F4D9BA57EF7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4128"/>
                <a:stretch/>
              </p:blipFill>
              <p:spPr bwMode="auto">
                <a:xfrm>
                  <a:off x="3814986" y="2305761"/>
                  <a:ext cx="1200764" cy="20955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xmlns="" id="{549E3E6B-0D1C-45CB-A9CF-E893C3A3B095}"/>
                    </a:ext>
                  </a:extLst>
                </p:cNvPr>
                <p:cNvSpPr txBox="1"/>
                <p:nvPr/>
              </p:nvSpPr>
              <p:spPr>
                <a:xfrm>
                  <a:off x="2950890" y="1752081"/>
                  <a:ext cx="6383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sz="1000" b="1" dirty="0">
                      <a:latin typeface="Arial" pitchFamily="34" charset="0"/>
                      <a:ea typeface="Arial" charset="0"/>
                      <a:cs typeface="Arial" pitchFamily="34" charset="0"/>
                    </a:rPr>
                    <a:t>B16F10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xmlns="" id="{6E05720A-C103-4EB2-9E54-C1D1391EAB43}"/>
                    </a:ext>
                  </a:extLst>
                </p:cNvPr>
                <p:cNvSpPr txBox="1"/>
                <p:nvPr/>
              </p:nvSpPr>
              <p:spPr>
                <a:xfrm>
                  <a:off x="4146432" y="1752080"/>
                  <a:ext cx="4892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sz="1000" b="1" dirty="0">
                      <a:latin typeface="Arial" pitchFamily="34" charset="0"/>
                      <a:ea typeface="Arial" charset="0"/>
                      <a:cs typeface="Arial" pitchFamily="34" charset="0"/>
                    </a:rPr>
                    <a:t>A375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xmlns="" id="{0D2F513E-0C59-43A0-8678-433C80666C44}"/>
                    </a:ext>
                  </a:extLst>
                </p:cNvPr>
                <p:cNvSpPr txBox="1"/>
                <p:nvPr/>
              </p:nvSpPr>
              <p:spPr>
                <a:xfrm>
                  <a:off x="4967114" y="2551525"/>
                  <a:ext cx="5950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0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64 </a:t>
                  </a:r>
                  <a:r>
                    <a:rPr lang="en-IN" sz="1000" b="1" dirty="0" err="1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kDa</a:t>
                  </a:r>
                  <a:endPara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xmlns="" id="{D15CBF53-3FC2-47A5-BC52-F42D25511C56}"/>
                    </a:ext>
                  </a:extLst>
                </p:cNvPr>
                <p:cNvSpPr txBox="1"/>
                <p:nvPr/>
              </p:nvSpPr>
              <p:spPr>
                <a:xfrm>
                  <a:off x="4967114" y="2287425"/>
                  <a:ext cx="5950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0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64 </a:t>
                  </a:r>
                  <a:r>
                    <a:rPr lang="en-IN" sz="1000" b="1" dirty="0" err="1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kDa</a:t>
                  </a:r>
                  <a:endParaRPr lang="en-IN" sz="1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xmlns="" id="{2A708C62-390E-432A-85B6-69867ED741F6}"/>
                    </a:ext>
                  </a:extLst>
                </p:cNvPr>
                <p:cNvSpPr txBox="1"/>
                <p:nvPr/>
              </p:nvSpPr>
              <p:spPr>
                <a:xfrm>
                  <a:off x="2103674" y="2533646"/>
                  <a:ext cx="4491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IN" sz="1000" b="1" dirty="0">
                      <a:latin typeface="Arial" charset="0"/>
                      <a:ea typeface="Arial" charset="0"/>
                      <a:cs typeface="Arial" charset="0"/>
                    </a:rPr>
                    <a:t>AKT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xmlns="" id="{92F0F8A6-F395-4483-A131-C5C66B323D7D}"/>
                    </a:ext>
                  </a:extLst>
                </p:cNvPr>
                <p:cNvSpPr txBox="1"/>
                <p:nvPr/>
              </p:nvSpPr>
              <p:spPr>
                <a:xfrm>
                  <a:off x="2022449" y="2290315"/>
                  <a:ext cx="5774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IN" sz="1000" b="1" dirty="0">
                      <a:latin typeface="Arial" charset="0"/>
                      <a:ea typeface="Arial" charset="0"/>
                      <a:cs typeface="Arial" charset="0"/>
                    </a:rPr>
                    <a:t>P-AKT</a:t>
                  </a:r>
                </a:p>
              </p:txBody>
            </p:sp>
          </p:grp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xmlns="" id="{F73E8274-6A1D-487A-B118-81B7F2E737B9}"/>
                  </a:ext>
                </a:extLst>
              </p:cNvPr>
              <p:cNvSpPr txBox="1"/>
              <p:nvPr/>
            </p:nvSpPr>
            <p:spPr>
              <a:xfrm rot="17175697">
                <a:off x="2374349" y="3142358"/>
                <a:ext cx="8690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p32 shRNA</a:t>
                </a:r>
                <a:endParaRPr lang="en-IN" sz="1000" b="1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4AC60F9A-E7D8-4CCD-8ACA-335A693FDE0C}"/>
                  </a:ext>
                </a:extLst>
              </p:cNvPr>
              <p:cNvSpPr txBox="1"/>
              <p:nvPr/>
            </p:nvSpPr>
            <p:spPr>
              <a:xfrm rot="17175697">
                <a:off x="2084993" y="3174364"/>
                <a:ext cx="9356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trl shRNA</a:t>
                </a:r>
              </a:p>
            </p:txBody>
          </p:sp>
          <p:grpSp>
            <p:nvGrpSpPr>
              <p:cNvPr id="33" name="Group 32"/>
              <p:cNvGrpSpPr/>
              <p:nvPr/>
            </p:nvGrpSpPr>
            <p:grpSpPr>
              <a:xfrm>
                <a:off x="2599851" y="1996366"/>
                <a:ext cx="2387442" cy="369332"/>
                <a:chOff x="2599851" y="1996366"/>
                <a:chExt cx="2387442" cy="369332"/>
              </a:xfrm>
            </p:grpSpPr>
            <p:sp>
              <p:nvSpPr>
                <p:cNvPr id="24" name="TextBox 23"/>
                <p:cNvSpPr txBox="1"/>
                <p:nvPr/>
              </p:nvSpPr>
              <p:spPr>
                <a:xfrm>
                  <a:off x="2599851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-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885497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-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3222928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+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3458253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+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847474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-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133120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-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4470551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+</a:t>
                  </a: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4705876" y="1996366"/>
                  <a:ext cx="2814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dirty="0"/>
                    <a:t>+</a:t>
                  </a:r>
                </a:p>
              </p:txBody>
            </p:sp>
          </p:grp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F73E8274-6A1D-487A-B118-81B7F2E737B9}"/>
                  </a:ext>
                </a:extLst>
              </p:cNvPr>
              <p:cNvSpPr txBox="1"/>
              <p:nvPr/>
            </p:nvSpPr>
            <p:spPr>
              <a:xfrm rot="17175697">
                <a:off x="3006462" y="3142358"/>
                <a:ext cx="8690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p32 shRNA</a:t>
                </a:r>
                <a:endParaRPr lang="en-IN" sz="1000" b="1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4AC60F9A-E7D8-4CCD-8ACA-335A693FDE0C}"/>
                  </a:ext>
                </a:extLst>
              </p:cNvPr>
              <p:cNvSpPr txBox="1"/>
              <p:nvPr/>
            </p:nvSpPr>
            <p:spPr>
              <a:xfrm rot="17175697">
                <a:off x="2660232" y="3174364"/>
                <a:ext cx="9356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trl shRN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F73E8274-6A1D-487A-B118-81B7F2E737B9}"/>
                  </a:ext>
                </a:extLst>
              </p:cNvPr>
              <p:cNvSpPr txBox="1"/>
              <p:nvPr/>
            </p:nvSpPr>
            <p:spPr>
              <a:xfrm rot="17175697">
                <a:off x="3725520" y="3142358"/>
                <a:ext cx="8690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p32 shRNA</a:t>
                </a:r>
                <a:endParaRPr lang="en-IN" sz="1000" b="1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xmlns="" id="{4AC60F9A-E7D8-4CCD-8ACA-335A693FDE0C}"/>
                  </a:ext>
                </a:extLst>
              </p:cNvPr>
              <p:cNvSpPr txBox="1"/>
              <p:nvPr/>
            </p:nvSpPr>
            <p:spPr>
              <a:xfrm rot="17175697">
                <a:off x="3436164" y="3174364"/>
                <a:ext cx="9356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trl shRNA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xmlns="" id="{F73E8274-6A1D-487A-B118-81B7F2E737B9}"/>
                  </a:ext>
                </a:extLst>
              </p:cNvPr>
              <p:cNvSpPr txBox="1"/>
              <p:nvPr/>
            </p:nvSpPr>
            <p:spPr>
              <a:xfrm rot="17175697">
                <a:off x="4357633" y="3142358"/>
                <a:ext cx="8690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000" b="1" dirty="0">
                    <a:latin typeface="Arial" charset="0"/>
                    <a:ea typeface="Arial" charset="0"/>
                    <a:cs typeface="Arial" charset="0"/>
                  </a:rPr>
                  <a:t>p32 shRNA</a:t>
                </a:r>
                <a:endParaRPr lang="en-IN" sz="1000" b="1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xmlns="" id="{4AC60F9A-E7D8-4CCD-8ACA-335A693FDE0C}"/>
                  </a:ext>
                </a:extLst>
              </p:cNvPr>
              <p:cNvSpPr txBox="1"/>
              <p:nvPr/>
            </p:nvSpPr>
            <p:spPr>
              <a:xfrm rot="17175697">
                <a:off x="4011403" y="3174364"/>
                <a:ext cx="9356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trl shRNA</a:t>
                </a:r>
              </a:p>
            </p:txBody>
          </p:sp>
        </p:grp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673035" y="853530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673289" y="3184002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673035" y="5779048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C</a:t>
            </a:r>
          </a:p>
        </p:txBody>
      </p:sp>
      <p:pic>
        <p:nvPicPr>
          <p:cNvPr id="47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7109" y="5779048"/>
            <a:ext cx="3853399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1880" y="3236795"/>
            <a:ext cx="3853399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1" name="Group 20"/>
          <p:cNvGrpSpPr/>
          <p:nvPr/>
        </p:nvGrpSpPr>
        <p:grpSpPr>
          <a:xfrm>
            <a:off x="4628193" y="858339"/>
            <a:ext cx="2634248" cy="2537961"/>
            <a:chOff x="4628193" y="1069555"/>
            <a:chExt cx="2634248" cy="2537961"/>
          </a:xfrm>
        </p:grpSpPr>
        <p:pic>
          <p:nvPicPr>
            <p:cNvPr id="45" name="Picture 2">
              <a:extLst>
                <a:ext uri="{FF2B5EF4-FFF2-40B4-BE49-F238E27FC236}">
                  <a16:creationId xmlns:a16="http://schemas.microsoft.com/office/drawing/2014/main" xmlns="" id="{F02AC027-6CEC-9D49-8047-E35E55DB9C8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2766"/>
            <a:stretch/>
          </p:blipFill>
          <p:spPr bwMode="auto">
            <a:xfrm>
              <a:off x="4628193" y="1367408"/>
              <a:ext cx="2310704" cy="22401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43178" y="1069555"/>
              <a:ext cx="1719263" cy="7556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549E3E6B-0D1C-45CB-A9CF-E893C3A3B095}"/>
              </a:ext>
            </a:extLst>
          </p:cNvPr>
          <p:cNvSpPr txBox="1"/>
          <p:nvPr/>
        </p:nvSpPr>
        <p:spPr>
          <a:xfrm>
            <a:off x="2811708" y="2924498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000" b="1" dirty="0">
                <a:latin typeface="Arial" pitchFamily="34" charset="0"/>
                <a:ea typeface="Arial" charset="0"/>
                <a:cs typeface="Arial" pitchFamily="34" charset="0"/>
              </a:rPr>
              <a:t>B16F1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6E05720A-C103-4EB2-9E54-C1D1391EAB43}"/>
              </a:ext>
            </a:extLst>
          </p:cNvPr>
          <p:cNvSpPr txBox="1"/>
          <p:nvPr/>
        </p:nvSpPr>
        <p:spPr>
          <a:xfrm>
            <a:off x="2977734" y="555033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000" b="1" dirty="0">
                <a:latin typeface="Arial" pitchFamily="34" charset="0"/>
                <a:ea typeface="Arial" charset="0"/>
                <a:cs typeface="Arial" pitchFamily="34" charset="0"/>
              </a:rPr>
              <a:t>A375</a:t>
            </a:r>
          </a:p>
        </p:txBody>
      </p:sp>
    </p:spTree>
    <p:extLst>
      <p:ext uri="{BB962C8B-B14F-4D97-AF65-F5344CB8AC3E}">
        <p14:creationId xmlns:p14="http://schemas.microsoft.com/office/powerpoint/2010/main" val="38609272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49068A38-7541-493F-BAE2-ED39AC6C6FCF}"/>
              </a:ext>
            </a:extLst>
          </p:cNvPr>
          <p:cNvSpPr txBox="1"/>
          <p:nvPr/>
        </p:nvSpPr>
        <p:spPr>
          <a:xfrm>
            <a:off x="422897" y="8575775"/>
            <a:ext cx="705678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9 (A)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Immunohistochemical analysis of the expression level of </a:t>
            </a:r>
            <a:r>
              <a:rPr lang="en-IN" sz="1200" dirty="0" err="1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AKT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in subcutaneous </a:t>
            </a:r>
            <a:r>
              <a:rPr lang="en-IN" sz="1200" dirty="0" err="1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tumors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and panel bar graphs represent their quantification;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(B)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qPCR showing relative mRNA expressions of 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EMT markers and oncogenes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umor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formed by control shRNA and p32shRNA B16F10 cells. All the data are represented as mean ± SD. Student’s t test was used for all statistical analyses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5 (***P &lt; 0.001, **P &lt; 0.01, *P &lt;0.05)</a:t>
            </a:r>
            <a:r>
              <a:rPr lang="en-IN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17D8CB9-D1E7-4FAF-9937-CC5EFC0ADB60}"/>
              </a:ext>
            </a:extLst>
          </p:cNvPr>
          <p:cNvSpPr txBox="1"/>
          <p:nvPr/>
        </p:nvSpPr>
        <p:spPr>
          <a:xfrm>
            <a:off x="142578" y="213974"/>
            <a:ext cx="3024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IN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1294706" y="1451080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52B5D54-5810-2747-AF0F-50646DC79DE9}"/>
              </a:ext>
            </a:extLst>
          </p:cNvPr>
          <p:cNvSpPr txBox="1"/>
          <p:nvPr/>
        </p:nvSpPr>
        <p:spPr>
          <a:xfrm>
            <a:off x="1294706" y="4381922"/>
            <a:ext cx="269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95696E02-93A1-4F4E-ADF9-7CAFB904F61D}"/>
              </a:ext>
            </a:extLst>
          </p:cNvPr>
          <p:cNvGrpSpPr/>
          <p:nvPr/>
        </p:nvGrpSpPr>
        <p:grpSpPr>
          <a:xfrm>
            <a:off x="1510730" y="1587043"/>
            <a:ext cx="5400601" cy="2428528"/>
            <a:chOff x="1510730" y="254759"/>
            <a:chExt cx="5400601" cy="2428528"/>
          </a:xfrm>
        </p:grpSpPr>
        <p:pic>
          <p:nvPicPr>
            <p:cNvPr id="8" name="Picture 2" descr="F:\p akt cdds\image8575.jpg">
              <a:extLst>
                <a:ext uri="{FF2B5EF4-FFF2-40B4-BE49-F238E27FC236}">
                  <a16:creationId xmlns:a16="http://schemas.microsoft.com/office/drawing/2014/main" xmlns="" id="{C90D5523-4B60-6E42-83B8-70EB862B7C1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10730" y="762000"/>
              <a:ext cx="1920000" cy="14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5" descr="F:\p akt cdds\image8585.jpg">
              <a:extLst>
                <a:ext uri="{FF2B5EF4-FFF2-40B4-BE49-F238E27FC236}">
                  <a16:creationId xmlns:a16="http://schemas.microsoft.com/office/drawing/2014/main" xmlns="" id="{E974A87F-1528-F145-8FE9-772063BAC0C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4750" y="767204"/>
              <a:ext cx="1920000" cy="14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E44A413A-06D1-9B4D-8B66-02E7E6919D20}"/>
                </a:ext>
              </a:extLst>
            </p:cNvPr>
            <p:cNvSpPr txBox="1"/>
            <p:nvPr/>
          </p:nvSpPr>
          <p:spPr>
            <a:xfrm>
              <a:off x="4994824" y="1933650"/>
              <a:ext cx="4299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500</a:t>
              </a:r>
              <a:r>
                <a:rPr lang="el-GR" sz="600" b="1" dirty="0"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m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xmlns="" id="{DF225525-7D65-8340-B4D9-C0A203535761}"/>
                </a:ext>
              </a:extLst>
            </p:cNvPr>
            <p:cNvCxnSpPr/>
            <p:nvPr/>
          </p:nvCxnSpPr>
          <p:spPr>
            <a:xfrm>
              <a:off x="5057357" y="2148928"/>
              <a:ext cx="3332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453B46B8-27D7-D445-8A93-D8A0608567BE}"/>
                </a:ext>
              </a:extLst>
            </p:cNvPr>
            <p:cNvSpPr txBox="1"/>
            <p:nvPr/>
          </p:nvSpPr>
          <p:spPr>
            <a:xfrm>
              <a:off x="2086794" y="515779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Ctrl shRN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DAF57E11-2772-934D-A1F6-796546B78A06}"/>
                </a:ext>
              </a:extLst>
            </p:cNvPr>
            <p:cNvSpPr txBox="1"/>
            <p:nvPr/>
          </p:nvSpPr>
          <p:spPr>
            <a:xfrm>
              <a:off x="4017029" y="506799"/>
              <a:ext cx="9380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b="1" dirty="0">
                  <a:latin typeface="Arial" charset="0"/>
                  <a:ea typeface="Arial" charset="0"/>
                  <a:cs typeface="Arial" charset="0"/>
                </a:rPr>
                <a:t>  p32 shRNA</a:t>
              </a:r>
              <a:endParaRPr lang="en-IN" sz="1000" b="1" baseline="300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xmlns="" id="{498E88B4-5D9E-D44C-A462-B84BEB3C4043}"/>
                </a:ext>
              </a:extLst>
            </p:cNvPr>
            <p:cNvCxnSpPr/>
            <p:nvPr/>
          </p:nvCxnSpPr>
          <p:spPr>
            <a:xfrm>
              <a:off x="1798762" y="506799"/>
              <a:ext cx="342523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559EF85F-D01D-024A-963F-B30A8830532A}"/>
                </a:ext>
              </a:extLst>
            </p:cNvPr>
            <p:cNvSpPr txBox="1"/>
            <p:nvPr/>
          </p:nvSpPr>
          <p:spPr>
            <a:xfrm>
              <a:off x="3022898" y="254759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b="1" dirty="0">
                  <a:latin typeface="Arial" charset="0"/>
                  <a:ea typeface="Arial" charset="0"/>
                  <a:cs typeface="Arial" charset="0"/>
                </a:rPr>
                <a:t>  p-</a:t>
              </a:r>
              <a:r>
                <a:rPr lang="en-IN" sz="1000" b="1" dirty="0" err="1">
                  <a:latin typeface="Arial" charset="0"/>
                  <a:ea typeface="Arial" charset="0"/>
                  <a:cs typeface="Arial" charset="0"/>
                </a:rPr>
                <a:t>Akt</a:t>
              </a:r>
              <a:endParaRPr lang="en-IN" sz="1000" b="1" baseline="3000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16" name="Picture 2">
              <a:extLst>
                <a:ext uri="{FF2B5EF4-FFF2-40B4-BE49-F238E27FC236}">
                  <a16:creationId xmlns:a16="http://schemas.microsoft.com/office/drawing/2014/main" xmlns="" id="{4BE301B5-DF8B-034A-9A43-CDFBC6B1D51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87195" y="254759"/>
              <a:ext cx="1224136" cy="24285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9488" y="4365317"/>
            <a:ext cx="4791075" cy="3638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74725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22</TotalTime>
  <Words>841</Words>
  <Application>Microsoft Office PowerPoint</Application>
  <PresentationFormat>Custom</PresentationFormat>
  <Paragraphs>112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er pc</dc:creator>
  <cp:lastModifiedBy>VR_LAB</cp:lastModifiedBy>
  <cp:revision>248</cp:revision>
  <cp:lastPrinted>2020-07-17T16:33:44Z</cp:lastPrinted>
  <dcterms:created xsi:type="dcterms:W3CDTF">2020-05-04T12:38:27Z</dcterms:created>
  <dcterms:modified xsi:type="dcterms:W3CDTF">2021-09-04T06:20:23Z</dcterms:modified>
</cp:coreProperties>
</file>